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10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345854-6294-413A-9C21-02DA63F77C4A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83535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TextBox 153"/>
          <p:cNvSpPr txBox="1"/>
          <p:nvPr/>
        </p:nvSpPr>
        <p:spPr>
          <a:xfrm>
            <a:off x="671712" y="7061488"/>
            <a:ext cx="570702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Fig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low cytometry gating strategies for cells isolated from the spinal cord, and thymus, spleen, and inguinal lymph node (LN).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Infiltrating and resident leukocytes were isolated from mouse spinal cords 15 or 18 days post injection with 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 using a discontinuous Percoll gradient. Cells were counted with a haemocytometer before being immunostained for markers of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crophages (CD11b+/CD45+ high), microglia (CD11b+/CD45+ low), CD4+ T cells (CD4+/CD3+), CD8+ T cells (CD8+/CD3+) and B cells (B220+/CD45+),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and analyzed by flow cytometry. To compare lymphocyte development between WT, cathepsin L- and cathepsin B/S-deficient mice, leukocytes were isolated from spleens, lymph nodes and thymuses of naïve mice using a discontinuous Percoll gradient and immunostained for markers of CD4+ T cells (CD4+/CD3+) and CD8+ T cells (CD8+/CD3+) and analyzed by flow cytometry.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403569" y="217802"/>
            <a:ext cx="3659762" cy="3619840"/>
            <a:chOff x="1402264" y="464022"/>
            <a:chExt cx="3659762" cy="3619840"/>
          </a:xfrm>
        </p:grpSpPr>
        <p:grpSp>
          <p:nvGrpSpPr>
            <p:cNvPr id="6" name="Group 5"/>
            <p:cNvGrpSpPr/>
            <p:nvPr/>
          </p:nvGrpSpPr>
          <p:grpSpPr>
            <a:xfrm>
              <a:off x="1402264" y="837394"/>
              <a:ext cx="3659762" cy="3246468"/>
              <a:chOff x="1570621" y="4238454"/>
              <a:chExt cx="3659762" cy="324646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1570621" y="4238454"/>
                <a:ext cx="3659762" cy="3246468"/>
                <a:chOff x="559717" y="4230269"/>
                <a:chExt cx="3659762" cy="3246468"/>
              </a:xfrm>
            </p:grpSpPr>
            <p:pic>
              <p:nvPicPr>
                <p:cNvPr id="151" name="Picture 150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082720" y="5631291"/>
                  <a:ext cx="687600" cy="687600"/>
                </a:xfrm>
                <a:prstGeom prst="rect">
                  <a:avLst/>
                </a:prstGeom>
              </p:spPr>
            </p:pic>
            <p:pic>
              <p:nvPicPr>
                <p:cNvPr id="150" name="Picture 149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231882" y="6239940"/>
                  <a:ext cx="687600" cy="687600"/>
                </a:xfrm>
                <a:prstGeom prst="rect">
                  <a:avLst/>
                </a:prstGeom>
              </p:spPr>
            </p:pic>
            <p:pic>
              <p:nvPicPr>
                <p:cNvPr id="149" name="Picture 148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545895" y="6239679"/>
                  <a:ext cx="687600" cy="687600"/>
                </a:xfrm>
                <a:prstGeom prst="rect">
                  <a:avLst/>
                </a:prstGeom>
              </p:spPr>
            </p:pic>
            <p:sp>
              <p:nvSpPr>
                <p:cNvPr id="144" name="TextBox 143"/>
                <p:cNvSpPr txBox="1"/>
                <p:nvPr/>
              </p:nvSpPr>
              <p:spPr>
                <a:xfrm>
                  <a:off x="2472341" y="5886471"/>
                  <a:ext cx="77461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Macrophage/Microglia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3254116" y="5979496"/>
                  <a:ext cx="7746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B cell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1" name="TextBox 110"/>
                <p:cNvSpPr txBox="1"/>
                <p:nvPr/>
              </p:nvSpPr>
              <p:spPr>
                <a:xfrm>
                  <a:off x="2554259" y="5095645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2" name="TextBox 111"/>
                <p:cNvSpPr txBox="1"/>
                <p:nvPr/>
              </p:nvSpPr>
              <p:spPr>
                <a:xfrm>
                  <a:off x="2789487" y="5097905"/>
                  <a:ext cx="50593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2961637" y="5096644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4" name="TextBox 113"/>
                <p:cNvSpPr txBox="1"/>
                <p:nvPr/>
              </p:nvSpPr>
              <p:spPr>
                <a:xfrm>
                  <a:off x="3122774" y="5094264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3281357" y="5094038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>
                  <a:off x="2482354" y="5408196"/>
                  <a:ext cx="77461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CD8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2550648" y="4868213"/>
                  <a:ext cx="50593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>
                  <a:off x="2554259" y="4703266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21" name="Straight Arrow Connector 120"/>
                <p:cNvCxnSpPr/>
                <p:nvPr/>
              </p:nvCxnSpPr>
              <p:spPr>
                <a:xfrm>
                  <a:off x="2564395" y="5389595"/>
                  <a:ext cx="457200" cy="1588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Arrow Connector 121"/>
                <p:cNvCxnSpPr/>
                <p:nvPr/>
              </p:nvCxnSpPr>
              <p:spPr>
                <a:xfrm rot="5400000" flipH="1" flipV="1">
                  <a:off x="2344089" y="5166985"/>
                  <a:ext cx="457200" cy="1588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3" name="TextBox 122"/>
                <p:cNvSpPr txBox="1"/>
                <p:nvPr/>
              </p:nvSpPr>
              <p:spPr>
                <a:xfrm rot="16200000">
                  <a:off x="2070371" y="4897217"/>
                  <a:ext cx="77461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CD4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76" name="Group 58"/>
                <p:cNvGrpSpPr/>
                <p:nvPr/>
              </p:nvGrpSpPr>
              <p:grpSpPr>
                <a:xfrm>
                  <a:off x="559717" y="5548984"/>
                  <a:ext cx="1496625" cy="1272991"/>
                  <a:chOff x="669686" y="7583174"/>
                  <a:chExt cx="1496625" cy="1272991"/>
                </a:xfrm>
              </p:grpSpPr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995998" y="8290160"/>
                    <a:ext cx="54049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5" name="TextBox 94"/>
                  <p:cNvSpPr txBox="1"/>
                  <p:nvPr/>
                </p:nvSpPr>
                <p:spPr>
                  <a:xfrm>
                    <a:off x="1144522" y="8292420"/>
                    <a:ext cx="50593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200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1403805" y="8288779"/>
                    <a:ext cx="54049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600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7" name="TextBox 96"/>
                  <p:cNvSpPr txBox="1"/>
                  <p:nvPr/>
                </p:nvSpPr>
                <p:spPr>
                  <a:xfrm>
                    <a:off x="1625820" y="8288553"/>
                    <a:ext cx="54049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1000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8" name="TextBox 97"/>
                  <p:cNvSpPr txBox="1"/>
                  <p:nvPr/>
                </p:nvSpPr>
                <p:spPr>
                  <a:xfrm>
                    <a:off x="902525" y="8102922"/>
                    <a:ext cx="50593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200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911422" y="7863971"/>
                    <a:ext cx="54049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600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0" name="TextBox 99"/>
                  <p:cNvSpPr txBox="1"/>
                  <p:nvPr/>
                </p:nvSpPr>
                <p:spPr>
                  <a:xfrm>
                    <a:off x="842056" y="7583174"/>
                    <a:ext cx="54049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1000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01" name="Group 92"/>
                  <p:cNvGrpSpPr/>
                  <p:nvPr/>
                </p:nvGrpSpPr>
                <p:grpSpPr>
                  <a:xfrm>
                    <a:off x="914144" y="8152744"/>
                    <a:ext cx="457200" cy="457200"/>
                    <a:chOff x="609590" y="2083234"/>
                    <a:chExt cx="457200" cy="457200"/>
                  </a:xfrm>
                </p:grpSpPr>
                <p:cxnSp>
                  <p:nvCxnSpPr>
                    <p:cNvPr id="108" name="Straight Arrow Connector 107"/>
                    <p:cNvCxnSpPr/>
                    <p:nvPr/>
                  </p:nvCxnSpPr>
                  <p:spPr>
                    <a:xfrm>
                      <a:off x="609590" y="2533650"/>
                      <a:ext cx="457200" cy="1588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arrow"/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9" name="Straight Arrow Connector 108"/>
                    <p:cNvCxnSpPr/>
                    <p:nvPr/>
                  </p:nvCxnSpPr>
                  <p:spPr>
                    <a:xfrm rot="5400000" flipH="1" flipV="1">
                      <a:off x="389284" y="2311040"/>
                      <a:ext cx="457200" cy="1588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arrow"/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839967" y="8609944"/>
                    <a:ext cx="77461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 pitchFamily="34" charset="0"/>
                        <a:cs typeface="Arial" pitchFamily="34" charset="0"/>
                      </a:rPr>
                      <a:t>SSC</a:t>
                    </a:r>
                    <a:endParaRPr 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3" name="TextBox 102"/>
                  <p:cNvSpPr txBox="1"/>
                  <p:nvPr/>
                </p:nvSpPr>
                <p:spPr>
                  <a:xfrm rot="16200000">
                    <a:off x="405490" y="8121231"/>
                    <a:ext cx="77461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 pitchFamily="34" charset="0"/>
                        <a:cs typeface="Arial" pitchFamily="34" charset="0"/>
                      </a:rPr>
                      <a:t>FSC</a:t>
                    </a:r>
                    <a:endParaRPr lang="en-US" sz="10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7" name="TextBox 106"/>
                  <p:cNvSpPr txBox="1"/>
                  <p:nvPr/>
                </p:nvSpPr>
                <p:spPr>
                  <a:xfrm>
                    <a:off x="1475116" y="7603095"/>
                    <a:ext cx="675873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33.9%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pic>
              <p:nvPicPr>
                <p:cNvPr id="110" name="Picture 109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826553" y="4435428"/>
                  <a:ext cx="687600" cy="687600"/>
                </a:xfrm>
                <a:prstGeom prst="rect">
                  <a:avLst/>
                </a:prstGeom>
              </p:spPr>
            </p:pic>
            <p:sp>
              <p:nvSpPr>
                <p:cNvPr id="118" name="TextBox 117"/>
                <p:cNvSpPr txBox="1"/>
                <p:nvPr/>
              </p:nvSpPr>
              <p:spPr>
                <a:xfrm>
                  <a:off x="2550080" y="4535517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>
                  <a:off x="2553611" y="4369609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" name="TextBox 124"/>
                <p:cNvSpPr txBox="1"/>
                <p:nvPr/>
              </p:nvSpPr>
              <p:spPr>
                <a:xfrm>
                  <a:off x="2831193" y="4436252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59.6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2778204" y="4230269"/>
                  <a:ext cx="7746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CD3+ T cells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" name="TextBox 128"/>
                <p:cNvSpPr txBox="1"/>
                <p:nvPr/>
              </p:nvSpPr>
              <p:spPr>
                <a:xfrm>
                  <a:off x="2273994" y="6917965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" name="TextBox 129"/>
                <p:cNvSpPr txBox="1"/>
                <p:nvPr/>
              </p:nvSpPr>
              <p:spPr>
                <a:xfrm>
                  <a:off x="2509222" y="6920225"/>
                  <a:ext cx="50593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" name="TextBox 130"/>
                <p:cNvSpPr txBox="1"/>
                <p:nvPr/>
              </p:nvSpPr>
              <p:spPr>
                <a:xfrm>
                  <a:off x="2681372" y="6918964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2" name="TextBox 131"/>
                <p:cNvSpPr txBox="1"/>
                <p:nvPr/>
              </p:nvSpPr>
              <p:spPr>
                <a:xfrm>
                  <a:off x="2842509" y="6916584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" name="TextBox 132"/>
                <p:cNvSpPr txBox="1"/>
                <p:nvPr/>
              </p:nvSpPr>
              <p:spPr>
                <a:xfrm>
                  <a:off x="3001092" y="6916358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" name="TextBox 133"/>
                <p:cNvSpPr txBox="1"/>
                <p:nvPr/>
              </p:nvSpPr>
              <p:spPr>
                <a:xfrm>
                  <a:off x="2270383" y="6690533"/>
                  <a:ext cx="50593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" name="TextBox 134"/>
                <p:cNvSpPr txBox="1"/>
                <p:nvPr/>
              </p:nvSpPr>
              <p:spPr>
                <a:xfrm>
                  <a:off x="2273994" y="6525586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" name="TextBox 135"/>
                <p:cNvSpPr txBox="1"/>
                <p:nvPr/>
              </p:nvSpPr>
              <p:spPr>
                <a:xfrm>
                  <a:off x="2269815" y="6357837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2273346" y="6191929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38" name="Group 51"/>
                <p:cNvGrpSpPr/>
                <p:nvPr/>
              </p:nvGrpSpPr>
              <p:grpSpPr>
                <a:xfrm>
                  <a:off x="2284130" y="6761499"/>
                  <a:ext cx="457200" cy="457200"/>
                  <a:chOff x="609590" y="2083234"/>
                  <a:chExt cx="457200" cy="457200"/>
                </a:xfrm>
              </p:grpSpPr>
              <p:cxnSp>
                <p:nvCxnSpPr>
                  <p:cNvPr id="139" name="Straight Arrow Connector 138"/>
                  <p:cNvCxnSpPr/>
                  <p:nvPr/>
                </p:nvCxnSpPr>
                <p:spPr>
                  <a:xfrm>
                    <a:off x="609590" y="2533650"/>
                    <a:ext cx="457200" cy="158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" name="Straight Arrow Connector 139"/>
                  <p:cNvCxnSpPr/>
                  <p:nvPr/>
                </p:nvCxnSpPr>
                <p:spPr>
                  <a:xfrm rot="5400000" flipH="1" flipV="1">
                    <a:off x="389284" y="2311040"/>
                    <a:ext cx="457200" cy="158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41" name="TextBox 140"/>
                <p:cNvSpPr txBox="1"/>
                <p:nvPr/>
              </p:nvSpPr>
              <p:spPr>
                <a:xfrm>
                  <a:off x="2202088" y="7230516"/>
                  <a:ext cx="103140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CD11b/B220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2840898" y="6182470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14.1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" name="TextBox 142"/>
                <p:cNvSpPr txBox="1"/>
                <p:nvPr/>
              </p:nvSpPr>
              <p:spPr>
                <a:xfrm>
                  <a:off x="2858533" y="6586679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28.1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 rot="16200000">
                  <a:off x="1760684" y="6720099"/>
                  <a:ext cx="77461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itchFamily="34" charset="0"/>
                      <a:cs typeface="Arial" pitchFamily="34" charset="0"/>
                    </a:rPr>
                    <a:t>CD45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3543606" y="6270250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4.39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8" name="Straight Arrow Connector 7"/>
                <p:cNvCxnSpPr/>
                <p:nvPr/>
              </p:nvCxnSpPr>
              <p:spPr>
                <a:xfrm flipV="1">
                  <a:off x="1857542" y="5440293"/>
                  <a:ext cx="531455" cy="28492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6" name="TextBox 125"/>
                <p:cNvSpPr txBox="1"/>
                <p:nvPr/>
              </p:nvSpPr>
              <p:spPr>
                <a:xfrm>
                  <a:off x="3170353" y="4802354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20.8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7" name="Straight Arrow Connector 36"/>
                <p:cNvCxnSpPr/>
                <p:nvPr/>
              </p:nvCxnSpPr>
              <p:spPr>
                <a:xfrm>
                  <a:off x="1843901" y="5827904"/>
                  <a:ext cx="462441" cy="349599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2" name="TextBox 151"/>
              <p:cNvSpPr txBox="1"/>
              <p:nvPr/>
            </p:nvSpPr>
            <p:spPr>
              <a:xfrm>
                <a:off x="2095377" y="5197547"/>
                <a:ext cx="77461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CNS Isolated</a:t>
                </a:r>
              </a:p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Leukocytes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2608115" y="464022"/>
              <a:ext cx="15508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NS Isolates</a:t>
              </a:r>
              <a:endParaRPr lang="en-CA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415106" y="3784592"/>
            <a:ext cx="4443481" cy="3243870"/>
            <a:chOff x="1403569" y="4531715"/>
            <a:chExt cx="4443481" cy="3243870"/>
          </a:xfrm>
        </p:grpSpPr>
        <p:grpSp>
          <p:nvGrpSpPr>
            <p:cNvPr id="4" name="Group 3"/>
            <p:cNvGrpSpPr/>
            <p:nvPr/>
          </p:nvGrpSpPr>
          <p:grpSpPr>
            <a:xfrm>
              <a:off x="1590356" y="4891963"/>
              <a:ext cx="3867126" cy="2883622"/>
              <a:chOff x="754574" y="744268"/>
              <a:chExt cx="3867126" cy="2883622"/>
            </a:xfrm>
          </p:grpSpPr>
          <p:pic>
            <p:nvPicPr>
              <p:cNvPr id="120" name="Picture 119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639421" y="1708120"/>
                <a:ext cx="687600" cy="687600"/>
              </a:xfrm>
              <a:prstGeom prst="rect">
                <a:avLst/>
              </a:prstGeom>
            </p:spPr>
          </p:pic>
          <p:pic>
            <p:nvPicPr>
              <p:cNvPr id="146" name="Picture 145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642183" y="1017532"/>
                <a:ext cx="687600" cy="687600"/>
              </a:xfrm>
              <a:prstGeom prst="rect">
                <a:avLst/>
              </a:prstGeom>
            </p:spPr>
          </p:pic>
          <p:sp>
            <p:nvSpPr>
              <p:cNvPr id="85" name="TextBox 84"/>
              <p:cNvSpPr txBox="1"/>
              <p:nvPr/>
            </p:nvSpPr>
            <p:spPr>
              <a:xfrm>
                <a:off x="3367224" y="1248305"/>
                <a:ext cx="12406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hymus</a:t>
                </a:r>
                <a:endParaRPr lang="en-CA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3374246" y="1869644"/>
                <a:ext cx="12406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pleen</a:t>
                </a:r>
                <a:endParaRPr lang="en-CA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7" name="Group 56"/>
              <p:cNvGrpSpPr/>
              <p:nvPr/>
            </p:nvGrpSpPr>
            <p:grpSpPr>
              <a:xfrm>
                <a:off x="754574" y="746243"/>
                <a:ext cx="3867126" cy="2881647"/>
                <a:chOff x="601975" y="1456878"/>
                <a:chExt cx="3867126" cy="2881647"/>
              </a:xfrm>
            </p:grpSpPr>
            <p:sp>
              <p:nvSpPr>
                <p:cNvPr id="29" name="TextBox 28"/>
                <p:cNvSpPr txBox="1"/>
                <p:nvPr/>
              </p:nvSpPr>
              <p:spPr>
                <a:xfrm>
                  <a:off x="2454411" y="1743212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65.9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2804222" y="1743212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6.47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2792347" y="2097439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20.9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2450314" y="2459410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66.8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2788250" y="2813637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29.9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73" name="Picture 72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796170" y="2418755"/>
                  <a:ext cx="687600" cy="687600"/>
                </a:xfrm>
                <a:prstGeom prst="rect">
                  <a:avLst/>
                </a:prstGeom>
              </p:spPr>
            </p:pic>
            <p:pic>
              <p:nvPicPr>
                <p:cNvPr id="71" name="Picture 70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1105053" y="2419213"/>
                  <a:ext cx="687600" cy="687600"/>
                </a:xfrm>
                <a:prstGeom prst="rect">
                  <a:avLst/>
                </a:prstGeom>
              </p:spPr>
            </p:pic>
            <p:pic>
              <p:nvPicPr>
                <p:cNvPr id="77" name="Picture 76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797984" y="3104912"/>
                  <a:ext cx="687600" cy="687600"/>
                </a:xfrm>
                <a:prstGeom prst="rect">
                  <a:avLst/>
                </a:prstGeom>
              </p:spPr>
            </p:pic>
            <p:pic>
              <p:nvPicPr>
                <p:cNvPr id="75" name="Picture 74"/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1104942" y="3106932"/>
                  <a:ext cx="687600" cy="687600"/>
                </a:xfrm>
                <a:prstGeom prst="rect">
                  <a:avLst/>
                </a:prstGeom>
              </p:spPr>
            </p:pic>
            <p:sp>
              <p:nvSpPr>
                <p:cNvPr id="42" name="TextBox 41"/>
                <p:cNvSpPr txBox="1"/>
                <p:nvPr/>
              </p:nvSpPr>
              <p:spPr>
                <a:xfrm>
                  <a:off x="821667" y="3779753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1056895" y="3782013"/>
                  <a:ext cx="50593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1229045" y="3780752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1390182" y="3778372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1548765" y="3778146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818056" y="3552321"/>
                  <a:ext cx="50593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1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821667" y="3387374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2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817488" y="3219625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821019" y="3053717"/>
                  <a:ext cx="54049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  <a:r>
                    <a:rPr lang="en-US" sz="800" baseline="30000" dirty="0" smtClean="0">
                      <a:latin typeface="Arial" pitchFamily="34" charset="0"/>
                      <a:cs typeface="Arial" pitchFamily="34" charset="0"/>
                    </a:rPr>
                    <a:t>4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51" name="Group 51"/>
                <p:cNvGrpSpPr/>
                <p:nvPr/>
              </p:nvGrpSpPr>
              <p:grpSpPr>
                <a:xfrm>
                  <a:off x="831803" y="3623287"/>
                  <a:ext cx="457200" cy="457200"/>
                  <a:chOff x="609590" y="2083234"/>
                  <a:chExt cx="457200" cy="457200"/>
                </a:xfrm>
              </p:grpSpPr>
              <p:cxnSp>
                <p:nvCxnSpPr>
                  <p:cNvPr id="52" name="Straight Arrow Connector 51"/>
                  <p:cNvCxnSpPr/>
                  <p:nvPr/>
                </p:nvCxnSpPr>
                <p:spPr>
                  <a:xfrm>
                    <a:off x="609590" y="2533650"/>
                    <a:ext cx="457200" cy="158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" name="Straight Arrow Connector 52"/>
                  <p:cNvCxnSpPr/>
                  <p:nvPr/>
                </p:nvCxnSpPr>
                <p:spPr>
                  <a:xfrm rot="5400000" flipH="1" flipV="1">
                    <a:off x="389284" y="2311040"/>
                    <a:ext cx="457200" cy="158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4" name="TextBox 53"/>
                <p:cNvSpPr txBox="1"/>
                <p:nvPr/>
              </p:nvSpPr>
              <p:spPr>
                <a:xfrm rot="16200000">
                  <a:off x="337779" y="3581325"/>
                  <a:ext cx="77461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itchFamily="34" charset="0"/>
                    </a:rPr>
                    <a:t>CD4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1035399" y="2412796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62.6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749762" y="4092304"/>
                  <a:ext cx="77461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itchFamily="34" charset="0"/>
                    </a:rPr>
                    <a:t>CD8</a:t>
                  </a:r>
                  <a:endParaRPr lang="en-US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1373335" y="2767023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33.4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1286758" y="1463987"/>
                  <a:ext cx="63246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en-CA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1868274" y="1456878"/>
                  <a:ext cx="12406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at L</a:t>
                  </a:r>
                  <a:r>
                    <a:rPr lang="en-CA" sz="1000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/-</a:t>
                  </a:r>
                  <a:endParaRPr lang="en-CA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1805299" y="2422696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21.9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2143235" y="2776923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69.3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1078802" y="3140869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56.2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1416738" y="3495096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42.5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1836827" y="3138894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2.1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2174763" y="3493121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84.5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79" name="Picture 78"/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1105053" y="1735096"/>
                  <a:ext cx="687600" cy="687600"/>
                </a:xfrm>
                <a:prstGeom prst="rect">
                  <a:avLst/>
                </a:prstGeom>
              </p:spPr>
            </p:pic>
            <p:pic>
              <p:nvPicPr>
                <p:cNvPr id="81" name="Picture 80"/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1795047" y="1730536"/>
                  <a:ext cx="687600" cy="687600"/>
                </a:xfrm>
                <a:prstGeom prst="rect">
                  <a:avLst/>
                </a:prstGeom>
              </p:spPr>
            </p:pic>
            <p:sp>
              <p:nvSpPr>
                <p:cNvPr id="87" name="TextBox 86"/>
                <p:cNvSpPr txBox="1"/>
                <p:nvPr/>
              </p:nvSpPr>
              <p:spPr>
                <a:xfrm>
                  <a:off x="3228418" y="3275002"/>
                  <a:ext cx="12406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 Nodes</a:t>
                  </a:r>
                  <a:endParaRPr lang="en-CA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>
                  <a:off x="1801015" y="1756216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29.8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2103326" y="1756216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10.8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2127076" y="2110443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51.4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1072851" y="1717544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63.2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1422662" y="1717544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8.01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1410787" y="2071771"/>
                  <a:ext cx="67587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latin typeface="Arial" panose="020B0604020202020204" pitchFamily="34" charset="0"/>
                      <a:cs typeface="Arial" pitchFamily="34" charset="0"/>
                    </a:rPr>
                    <a:t>21.2%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pic>
            <p:nvPicPr>
              <p:cNvPr id="128" name="Picture 127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2643150" y="2395720"/>
                <a:ext cx="687600" cy="687600"/>
              </a:xfrm>
              <a:prstGeom prst="rect">
                <a:avLst/>
              </a:prstGeom>
            </p:spPr>
          </p:pic>
          <p:sp>
            <p:nvSpPr>
              <p:cNvPr id="153" name="TextBox 152"/>
              <p:cNvSpPr txBox="1"/>
              <p:nvPr/>
            </p:nvSpPr>
            <p:spPr>
              <a:xfrm>
                <a:off x="2695773" y="744268"/>
                <a:ext cx="12406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at </a:t>
                </a:r>
                <a:r>
                  <a:rPr lang="en-CA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CA" sz="10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r>
                  <a:rPr lang="en-CA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CA" sz="10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endParaRPr lang="en-CA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>
                <a:off x="2638691" y="2376175"/>
                <a:ext cx="6758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itchFamily="34" charset="0"/>
                  </a:rPr>
                  <a:t>61.3%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2976627" y="2730402"/>
                <a:ext cx="6758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itchFamily="34" charset="0"/>
                  </a:rPr>
                  <a:t>37.5%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57" name="TextBox 156"/>
            <p:cNvSpPr txBox="1"/>
            <p:nvPr/>
          </p:nvSpPr>
          <p:spPr>
            <a:xfrm>
              <a:off x="1403569" y="4531715"/>
              <a:ext cx="44434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ymus, Spleen and LN Isolates</a:t>
              </a:r>
              <a:endParaRPr lang="en-CA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77117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301</Words>
  <Application>Microsoft Office PowerPoint</Application>
  <PresentationFormat>On-screen Show (4:3)</PresentationFormat>
  <Paragraphs>8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7:53Z</dcterms:modified>
</cp:coreProperties>
</file>